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B5"/>
    <a:srgbClr val="004277"/>
    <a:srgbClr val="296DC0"/>
    <a:srgbClr val="AA0065"/>
    <a:srgbClr val="0092F7"/>
    <a:srgbClr val="65AA00"/>
    <a:srgbClr val="00437A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995" autoAdjust="0"/>
    <p:restoredTop sz="96144" autoAdjust="0"/>
  </p:normalViewPr>
  <p:slideViewPr>
    <p:cSldViewPr snapToGrid="0">
      <p:cViewPr>
        <p:scale>
          <a:sx n="88" d="100"/>
          <a:sy n="88" d="100"/>
        </p:scale>
        <p:origin x="-1080" y="-19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Vitamin and trace element concentrations in infants and children                              with chronic kidney diseas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410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We investigated blood concentrations of trace elements and vitamins in non-dialysis stages 3-5 of CK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81954" y="1843211"/>
            <a:ext cx="11505934" cy="37087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sz="2400" dirty="0">
              <a:solidFill>
                <a:srgbClr val="0065AA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                               88 were on diet alone</a:t>
            </a:r>
          </a:p>
          <a:p>
            <a:r>
              <a:rPr lang="en-GB" dirty="0">
                <a:solidFill>
                  <a:srgbClr val="0065AA"/>
                </a:solidFill>
              </a:rPr>
              <a:t>                       Retrospective</a:t>
            </a:r>
          </a:p>
          <a:p>
            <a:r>
              <a:rPr lang="en-GB" dirty="0">
                <a:solidFill>
                  <a:srgbClr val="0065AA"/>
                </a:solidFill>
              </a:rPr>
              <a:t>	      cross-sectional study            20 receiving enteral</a:t>
            </a: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                               tube feeds  </a:t>
            </a:r>
          </a:p>
          <a:p>
            <a:endParaRPr lang="en-GB" sz="400" dirty="0">
              <a:solidFill>
                <a:srgbClr val="0065AA"/>
              </a:solidFill>
            </a:endParaRPr>
          </a:p>
          <a:p>
            <a:pPr lvl="0"/>
            <a:r>
              <a:rPr lang="en-GB" sz="900" dirty="0">
                <a:solidFill>
                  <a:srgbClr val="0065AA"/>
                </a:solidFill>
              </a:rPr>
              <a:t>                                                                                                                                                          </a:t>
            </a:r>
          </a:p>
          <a:p>
            <a:r>
              <a:rPr lang="en-GB" dirty="0">
                <a:solidFill>
                  <a:srgbClr val="0065AA"/>
                </a:solidFill>
              </a:rPr>
              <a:t>112 children (70 boys)                                4 receiving oral </a:t>
            </a:r>
          </a:p>
          <a:p>
            <a:r>
              <a:rPr lang="en-GB" dirty="0">
                <a:solidFill>
                  <a:srgbClr val="0065AA"/>
                </a:solidFill>
              </a:rPr>
              <a:t>Median age 8.9 years                                  nutritional supplements </a:t>
            </a:r>
          </a:p>
          <a:p>
            <a:r>
              <a:rPr lang="en-GB" dirty="0">
                <a:solidFill>
                  <a:srgbClr val="0065AA"/>
                </a:solidFill>
              </a:rPr>
              <a:t>Median eGFR 28</a:t>
            </a:r>
            <a:r>
              <a:rPr lang="en-GB" dirty="0">
                <a:solidFill>
                  <a:srgbClr val="0066B5"/>
                </a:solidFill>
              </a:rPr>
              <a:t>ml/min/1.73m</a:t>
            </a:r>
            <a:r>
              <a:rPr lang="en-GB" baseline="30000" dirty="0">
                <a:solidFill>
                  <a:srgbClr val="0066B5"/>
                </a:solidFill>
              </a:rPr>
              <a:t>2</a:t>
            </a:r>
            <a:endParaRPr lang="en-GB" dirty="0">
              <a:solidFill>
                <a:srgbClr val="0066B5"/>
              </a:solidFill>
            </a:endParaRP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                              19 receiving a </a:t>
            </a:r>
          </a:p>
          <a:p>
            <a:r>
              <a:rPr lang="en-GB" dirty="0">
                <a:solidFill>
                  <a:srgbClr val="0065AA"/>
                </a:solidFill>
              </a:rPr>
              <a:t>                                                                       micronutrient supplement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Joyce et al. 2020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Monitoring of vitamin D and zinc blood concentrations is indicated in this group.  Targeted supplementation should be considered rather than commencing a multivitamin and/or mineral supplement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=""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10528" y="251453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=""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942042" y="252131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=""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685400" y="261656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1634066" y="3483007"/>
            <a:ext cx="1894397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668703" y="2352041"/>
            <a:ext cx="298450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668704" y="2998203"/>
            <a:ext cx="298450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676634" y="3710732"/>
            <a:ext cx="298450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641176" y="4496009"/>
            <a:ext cx="298450" cy="523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38823" y="1953553"/>
            <a:ext cx="5653177" cy="3425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7</Words>
  <Application>Microsoft Office PowerPoint</Application>
  <PresentationFormat>Custom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0-03-03T21:08:21Z</dcterms:modified>
</cp:coreProperties>
</file>